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4" r:id="rId2"/>
    <p:sldId id="256" r:id="rId3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>
      <p:cViewPr varScale="1">
        <p:scale>
          <a:sx n="96" d="100"/>
          <a:sy n="96" d="100"/>
        </p:scale>
        <p:origin x="331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817DC-9228-D14F-A30D-E924C6B4A0D6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10C44-312C-F04E-A772-75B90DC81F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1047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817DC-9228-D14F-A30D-E924C6B4A0D6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10C44-312C-F04E-A772-75B90DC81F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74877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817DC-9228-D14F-A30D-E924C6B4A0D6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10C44-312C-F04E-A772-75B90DC81F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40376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817DC-9228-D14F-A30D-E924C6B4A0D6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10C44-312C-F04E-A772-75B90DC81F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61286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817DC-9228-D14F-A30D-E924C6B4A0D6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10C44-312C-F04E-A772-75B90DC81F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85377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817DC-9228-D14F-A30D-E924C6B4A0D6}" type="datetimeFigureOut">
              <a:rPr lang="en-US" smtClean="0"/>
              <a:t>2/2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10C44-312C-F04E-A772-75B90DC81F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4375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817DC-9228-D14F-A30D-E924C6B4A0D6}" type="datetimeFigureOut">
              <a:rPr lang="en-US" smtClean="0"/>
              <a:t>2/21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10C44-312C-F04E-A772-75B90DC81F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91890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817DC-9228-D14F-A30D-E924C6B4A0D6}" type="datetimeFigureOut">
              <a:rPr lang="en-US" smtClean="0"/>
              <a:t>2/21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10C44-312C-F04E-A772-75B90DC81F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19729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817DC-9228-D14F-A30D-E924C6B4A0D6}" type="datetimeFigureOut">
              <a:rPr lang="en-US" smtClean="0"/>
              <a:t>2/21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10C44-312C-F04E-A772-75B90DC81F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55908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817DC-9228-D14F-A30D-E924C6B4A0D6}" type="datetimeFigureOut">
              <a:rPr lang="en-US" smtClean="0"/>
              <a:t>2/2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10C44-312C-F04E-A772-75B90DC81F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766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817DC-9228-D14F-A30D-E924C6B4A0D6}" type="datetimeFigureOut">
              <a:rPr lang="en-US" smtClean="0"/>
              <a:t>2/2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10C44-312C-F04E-A772-75B90DC81F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78914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6817DC-9228-D14F-A30D-E924C6B4A0D6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610C44-312C-F04E-A772-75B90DC81F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06567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AC154BEB-6F8F-6042-8005-3031C0D124A5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93443" y="348609"/>
            <a:ext cx="3358874" cy="3343334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B66AD5DC-8F67-AC4A-B079-789FEDD73CB4}"/>
              </a:ext>
            </a:extLst>
          </p:cNvPr>
          <p:cNvSpPr txBox="1"/>
          <p:nvPr/>
        </p:nvSpPr>
        <p:spPr>
          <a:xfrm>
            <a:off x="2504559" y="8600022"/>
            <a:ext cx="2114618" cy="3002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1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BC7247DB-733C-DB45-B5A2-66792A32FDFD}"/>
              </a:ext>
            </a:extLst>
          </p:cNvPr>
          <p:cNvGrpSpPr/>
          <p:nvPr/>
        </p:nvGrpSpPr>
        <p:grpSpPr>
          <a:xfrm>
            <a:off x="4573710" y="289808"/>
            <a:ext cx="1342558" cy="3857443"/>
            <a:chOff x="1165763" y="847914"/>
            <a:chExt cx="1788213" cy="5137900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FD36795B-0A32-6F41-B479-70C98C4C7FC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165763" y="1217246"/>
              <a:ext cx="1788213" cy="4768568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DA9C76A2-ABF5-8043-A5AA-ECBA41BC2CE3}"/>
                </a:ext>
              </a:extLst>
            </p:cNvPr>
            <p:cNvSpPr txBox="1"/>
            <p:nvPr/>
          </p:nvSpPr>
          <p:spPr>
            <a:xfrm>
              <a:off x="1250456" y="847914"/>
              <a:ext cx="1181143" cy="399863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</p:spPr>
          <p:txBody>
            <a:bodyPr wrap="none" rtlCol="0">
              <a:spAutoFit/>
            </a:bodyPr>
            <a:lstStyle/>
            <a:p>
              <a:r>
                <a:rPr lang="en-US" sz="1351" dirty="0">
                  <a:latin typeface="Arial" panose="020B0604020202020204" pitchFamily="34" charset="0"/>
                  <a:cs typeface="Arial" panose="020B0604020202020204" pitchFamily="34" charset="0"/>
                </a:rPr>
                <a:t>Cell lines</a:t>
              </a:r>
            </a:p>
          </p:txBody>
        </p:sp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F1E375C1-1428-7241-8037-EFDDE581A830}"/>
              </a:ext>
            </a:extLst>
          </p:cNvPr>
          <p:cNvGrpSpPr/>
          <p:nvPr/>
        </p:nvGrpSpPr>
        <p:grpSpPr>
          <a:xfrm>
            <a:off x="150542" y="4152973"/>
            <a:ext cx="6386923" cy="2044562"/>
            <a:chOff x="3193774" y="847914"/>
            <a:chExt cx="8998226" cy="2980875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B386D1B3-8DD4-394E-BD33-4CC49E74DA2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193774" y="1184980"/>
              <a:ext cx="8998226" cy="2643809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88D0287C-FEFC-DF41-88BA-A435DC9DBF85}"/>
                </a:ext>
              </a:extLst>
            </p:cNvPr>
            <p:cNvSpPr txBox="1"/>
            <p:nvPr/>
          </p:nvSpPr>
          <p:spPr>
            <a:xfrm>
              <a:off x="3513068" y="847914"/>
              <a:ext cx="7686126" cy="740768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</p:spPr>
          <p:txBody>
            <a:bodyPr wrap="square" rtlCol="0">
              <a:spAutoFit/>
            </a:bodyPr>
            <a:lstStyle/>
            <a:p>
              <a:r>
                <a:rPr lang="en-US" sz="1351" dirty="0">
                  <a:latin typeface="Arial" panose="020B0604020202020204" pitchFamily="34" charset="0"/>
                  <a:cs typeface="Arial" panose="020B0604020202020204" pitchFamily="34" charset="0"/>
                </a:rPr>
                <a:t>TCGA PRAD cohort: 233 EA and 37 AA: Distinguish TMRPSS2 fusion</a:t>
              </a:r>
            </a:p>
          </p:txBody>
        </p:sp>
      </p:grpSp>
      <p:grpSp>
        <p:nvGrpSpPr>
          <p:cNvPr id="13" name="Group 12">
            <a:extLst>
              <a:ext uri="{FF2B5EF4-FFF2-40B4-BE49-F238E27FC236}">
                <a16:creationId xmlns:a16="http://schemas.microsoft.com/office/drawing/2014/main" id="{AD0889FD-516C-B549-AB17-D61547ED7665}"/>
              </a:ext>
            </a:extLst>
          </p:cNvPr>
          <p:cNvGrpSpPr/>
          <p:nvPr/>
        </p:nvGrpSpPr>
        <p:grpSpPr>
          <a:xfrm>
            <a:off x="428349" y="6491000"/>
            <a:ext cx="5397920" cy="2085905"/>
            <a:chOff x="3279913" y="3921801"/>
            <a:chExt cx="7189729" cy="2778309"/>
          </a:xfrm>
        </p:grpSpPr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31795D53-D144-0A43-BBA9-49A1A029D77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279913" y="4384145"/>
              <a:ext cx="6561900" cy="2315965"/>
            </a:xfrm>
            <a:prstGeom prst="rect">
              <a:avLst/>
            </a:prstGeom>
          </p:spPr>
        </p:pic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435DEF2B-3E6B-744A-87F3-EFF7376319C3}"/>
                </a:ext>
              </a:extLst>
            </p:cNvPr>
            <p:cNvSpPr/>
            <p:nvPr/>
          </p:nvSpPr>
          <p:spPr>
            <a:xfrm>
              <a:off x="8494238" y="3921801"/>
              <a:ext cx="1975404" cy="399863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</p:spPr>
          <p:txBody>
            <a:bodyPr wrap="none">
              <a:spAutoFit/>
            </a:bodyPr>
            <a:lstStyle/>
            <a:p>
              <a:r>
                <a:rPr lang="en-US" sz="1351" dirty="0">
                  <a:solidFill>
                    <a:srgbClr val="21212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MID: 34083737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0EACE088-0309-FF4F-BB66-493474854383}"/>
                </a:ext>
              </a:extLst>
            </p:cNvPr>
            <p:cNvSpPr txBox="1"/>
            <p:nvPr/>
          </p:nvSpPr>
          <p:spPr>
            <a:xfrm>
              <a:off x="3559449" y="3921801"/>
              <a:ext cx="4383980" cy="399863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</p:spPr>
          <p:txBody>
            <a:bodyPr wrap="none" rtlCol="0">
              <a:spAutoFit/>
            </a:bodyPr>
            <a:lstStyle/>
            <a:p>
              <a:r>
                <a:rPr lang="en-US" sz="1351" dirty="0">
                  <a:latin typeface="Arial" panose="020B0604020202020204" pitchFamily="34" charset="0"/>
                  <a:cs typeface="Arial" panose="020B0604020202020204" pitchFamily="34" charset="0"/>
                </a:rPr>
                <a:t>Rayford et al cohort: 556 EA and 596 AA</a:t>
              </a:r>
            </a:p>
          </p:txBody>
        </p: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936A78CC-557F-CE4D-B19B-1295B86D64DC}"/>
              </a:ext>
            </a:extLst>
          </p:cNvPr>
          <p:cNvSpPr txBox="1"/>
          <p:nvPr/>
        </p:nvSpPr>
        <p:spPr>
          <a:xfrm>
            <a:off x="207414" y="214219"/>
            <a:ext cx="311207" cy="3696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2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5412A17-65AD-884C-B228-3567D7FB6BE7}"/>
              </a:ext>
            </a:extLst>
          </p:cNvPr>
          <p:cNvSpPr txBox="1"/>
          <p:nvPr/>
        </p:nvSpPr>
        <p:spPr>
          <a:xfrm>
            <a:off x="4052319" y="220486"/>
            <a:ext cx="311207" cy="3696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2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3DD75E3-EFEA-9843-B83B-7EE66141A329}"/>
              </a:ext>
            </a:extLst>
          </p:cNvPr>
          <p:cNvSpPr txBox="1"/>
          <p:nvPr/>
        </p:nvSpPr>
        <p:spPr>
          <a:xfrm>
            <a:off x="75424" y="6536771"/>
            <a:ext cx="311207" cy="3696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2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7561750-18FB-FD46-A016-296BADBDD000}"/>
              </a:ext>
            </a:extLst>
          </p:cNvPr>
          <p:cNvSpPr txBox="1"/>
          <p:nvPr/>
        </p:nvSpPr>
        <p:spPr>
          <a:xfrm>
            <a:off x="207413" y="3691944"/>
            <a:ext cx="311207" cy="3696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2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82455677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127CB1CE-129D-5DC6-D444-A892C120C8BC}"/>
              </a:ext>
            </a:extLst>
          </p:cNvPr>
          <p:cNvSpPr txBox="1"/>
          <p:nvPr/>
        </p:nvSpPr>
        <p:spPr>
          <a:xfrm>
            <a:off x="278296" y="370850"/>
            <a:ext cx="6347791" cy="193899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Supplementary Figure 11. Expression of genes in BAZ containing complexes. A.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Correlations between either BAZ1A or SMARCA5 and the 1α,25(OH)</a:t>
            </a:r>
            <a:r>
              <a:rPr lang="en-US" sz="1200" baseline="-25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2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D</a:t>
            </a:r>
            <a:r>
              <a:rPr lang="en-US" sz="1200" baseline="-25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3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-regulated genes from RC43N and RC43T in the AA TMPRSS2 fusion negative tumors from the TCGA-PRAD cohort. Genes were filtered in </a:t>
            </a:r>
            <a:r>
              <a:rPr lang="en-US" sz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Hallmarks_InflammatoryResponse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and </a:t>
            </a:r>
            <a:r>
              <a:rPr lang="en-US" sz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GO_Circadian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Rhythm. 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B.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 Genes in BAZ1A containing SWI/SNF complexes distinguished the AA from the EA cell line models. 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C.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The most altered genes in this complex also significantly distinguished </a:t>
            </a:r>
            <a:r>
              <a:rPr lang="en-US" sz="12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TMPRSS2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fusion positive from negative tumors in the TCGA-PRAD cohort (chi-squared p = 0.002). 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D.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Expression of genes in all four SWI/SNF complexes in the Rayford et al cohort of AA tumors (n = 596) compared to EA tumors (n = 556) we significantly down-regulated in AA tumors compared to EA counterparts.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5933262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</TotalTime>
  <Words>188</Words>
  <Application>Microsoft Macintosh PowerPoint</Application>
  <PresentationFormat>Letter Paper (8.5x11 in)</PresentationFormat>
  <Paragraphs>1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ray Campbell</dc:creator>
  <cp:lastModifiedBy>Moray Campbell</cp:lastModifiedBy>
  <cp:revision>1</cp:revision>
  <dcterms:created xsi:type="dcterms:W3CDTF">2023-02-21T20:00:51Z</dcterms:created>
  <dcterms:modified xsi:type="dcterms:W3CDTF">2023-02-21T20:01:59Z</dcterms:modified>
</cp:coreProperties>
</file>